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61" r:id="rId3"/>
    <p:sldId id="262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6" d="100"/>
          <a:sy n="76" d="100"/>
        </p:scale>
        <p:origin x="1416" y="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30/05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71784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76819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5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5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5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5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5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5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5/2019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5/2019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5/2019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5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30/05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30/05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26996" y="5736769"/>
            <a:ext cx="799288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Sharp and Lawlor (2019) Diabetologia DOI 10.1007/s00125-019-4919-9</a:t>
            </a:r>
          </a:p>
          <a:p>
            <a:r>
              <a:rPr lang="en-GB" sz="1200" dirty="0"/>
              <a:t>© The Authors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338567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7" y="129426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Potential mechanism through which fathers might impact offspring health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1B14F2E1-6E45-446B-B2EF-501BF1EC364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19434" y="529536"/>
            <a:ext cx="3905131" cy="55637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847866"/>
            <a:ext cx="799288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Sharp and Lawlor (2019) Diabetologia DOI 10.1007/s00125-019-4919-9</a:t>
            </a:r>
          </a:p>
          <a:p>
            <a:r>
              <a:rPr lang="en-GB" sz="1200" dirty="0"/>
              <a:t>© The Authors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338567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7" y="129426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Transgenerational and intergenerational epigenetic inheritance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D208EE24-4A8A-4B61-AF64-D120B17BA61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94201" y="764704"/>
            <a:ext cx="5355597" cy="51936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768303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847866"/>
            <a:ext cx="799288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Sharp and Lawlor (2019) Diabetologia DOI 10.1007/s00125-019-4919-9</a:t>
            </a:r>
          </a:p>
          <a:p>
            <a:r>
              <a:rPr lang="en-GB" sz="1200"/>
              <a:t>© The Authors</a:t>
            </a:r>
            <a:endParaRPr lang="en-GB" sz="1200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338567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7" y="129426"/>
            <a:ext cx="871296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Summary of the outcomes, exposures and mechanisms explored by 116 studies that showed at least correlative evidence linking paternal characteristics to offspring risk of obesity and type 2 diabetes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C7B11606-70BE-43DB-868E-372F8B4DD3D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55576" y="1423479"/>
            <a:ext cx="7846647" cy="43130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630716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0</TotalTime>
  <Words>89</Words>
  <Application>Microsoft Office PowerPoint</Application>
  <PresentationFormat>On-screen Show (4:3)</PresentationFormat>
  <Paragraphs>15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Charlotte Taylor</cp:lastModifiedBy>
  <cp:revision>29</cp:revision>
  <dcterms:created xsi:type="dcterms:W3CDTF">2016-06-15T12:53:43Z</dcterms:created>
  <dcterms:modified xsi:type="dcterms:W3CDTF">2019-05-30T12:14:09Z</dcterms:modified>
</cp:coreProperties>
</file>